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144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C069C-4F32-4F1E-8A66-D5A3F8E047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AD9913-B8C1-47DE-8F50-1E364062B9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4BAC50-567D-4E9D-8681-0B0BCECB3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6C71D-E506-4890-B6AB-7E1EE7191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47F14-4D78-4640-8C3D-C9585861B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2068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5B94D3-EA9D-4A8A-BCDD-979828521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74E3D8-1BA7-4141-8783-B82C31BFDB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1AD403-991C-4E3B-ADDA-D91255180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D75A7A-7FA9-46C8-A0AC-79BBF1860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8A44BE-895B-46C6-8485-841D0A9CD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5595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ADFF1F-A377-4329-B8F2-6A89F5481E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1AE1E8-FBE6-477C-8F9F-7EF5DF8A94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B6363E-8F13-48A2-BFCF-C907FD308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9DCC60-DF30-42EB-BDC6-2FF9102FC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530750-A73D-4E77-B266-3E01049FF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3258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B02334-7890-4059-B516-EF855DD04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C504F3-63DA-4FBE-9B13-E85ECF001A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31D9A5-81BA-4C96-A180-FF9403C8E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9C39F0-B810-4299-8CAA-654BD7A11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AB808E-9FAD-4996-9EB4-EFB7A746C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858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89C715-43A3-4817-9F74-D9A17EBB9C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F42F1B-AB20-43FD-A203-37AA5C0EC4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A444EF-3262-4597-91D1-BA7D88AF5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9EFD3E-DCEE-46EE-A597-FBC1E69F6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7E71AB-ACC5-4986-A28E-9B209B3ED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959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4765E-515D-4DCE-927A-A840C0BDB2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BDAE14-E69A-4BB4-963D-7D399FCF79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CFCAB5-FC16-4CA6-815B-0EAE6E179C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F22575-BF02-447E-A264-F021D2795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1BB1CB-A824-4A30-8094-70207B2B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950BE8-B022-444B-8F1A-FB92787B5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402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82524A-4B81-4DAB-B407-73A0ECE2F7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4218D3-C380-4B7D-8926-0BC8B6D856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238D6D-82BB-4B8C-8256-A81B5B0A9C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1A93FB-A566-44D2-BED9-F545B90B7E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9D9508-1E6E-4AC2-A32B-E79D35F284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98EA83-9FCE-4C3E-84EF-0231E51B8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8DFE14-5BFB-40A7-93F0-2F521C834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176721-12B5-47D5-9113-7EE3D4DC5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402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DD04EC-63F7-4274-B024-A03A79272B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DE2D48-0E62-4DD4-B132-E50380792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9EFDBF-4845-4AA7-ADE0-DD33510FC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52376F-66FA-4D37-B671-68B405D16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3086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ED8D39-193C-4101-8ED0-A1005F8F6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184735-2805-4728-A900-E434ED7AF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B0ED34-EBB8-4387-8A27-9EABC6EB4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717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278FD1-D9BE-4CC6-BE42-95BE802C0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73541-7FEA-4D37-A91D-D8C6C82EBD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8B2C11-9207-4DE9-AC55-C2D886CC02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6B49EF-3C1D-4789-8042-2E05A58F7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27ABD9-B27E-42B6-A604-F19444549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CE7C2E-05CE-40C1-B260-F45FFB89F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769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AFDA0C-2755-4E8A-A424-F95CAC9F5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2D5B71-E8F2-4C73-B8E1-E253361644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C2F0E3-E3AB-4AC6-98C4-891F1A8ED1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2703F4-A9EA-46E0-9D01-E3530C0DD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1E0665-7271-4063-B054-5B788F265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4A50E9-0DCD-4BD3-95C0-E342D8492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5996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C7FDA3-C857-4184-BDFD-95D60586C1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71B3DE-E474-4142-923D-9DD6FEAEE9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4A2B18-3DB6-47DF-AA8F-0945C69248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6B557-59E8-4C92-AA74-3B642D5431B4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A7CC7-5683-4953-B0E0-5D39A9C382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8FB7AB-8856-40D1-A50C-5F0F6BA63C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7989B-1B56-480E-B08D-5A9C1C26C28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161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9C8E75-F8E2-485D-8346-491B9CD020BF}"/>
              </a:ext>
            </a:extLst>
          </p:cNvPr>
          <p:cNvSpPr txBox="1"/>
          <p:nvPr/>
        </p:nvSpPr>
        <p:spPr>
          <a:xfrm>
            <a:off x="10759107" y="30174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9833D73-D3E4-4BA2-91EC-988423145624}"/>
              </a:ext>
            </a:extLst>
          </p:cNvPr>
          <p:cNvSpPr txBox="1"/>
          <p:nvPr/>
        </p:nvSpPr>
        <p:spPr>
          <a:xfrm>
            <a:off x="4064513" y="142860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2B5140-310B-45D0-A52C-946DC81374DB}"/>
              </a:ext>
            </a:extLst>
          </p:cNvPr>
          <p:cNvSpPr txBox="1"/>
          <p:nvPr/>
        </p:nvSpPr>
        <p:spPr>
          <a:xfrm>
            <a:off x="5257805" y="142860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79B189-D04A-415B-9D9F-257C5FDAA8C1}"/>
              </a:ext>
            </a:extLst>
          </p:cNvPr>
          <p:cNvSpPr txBox="1"/>
          <p:nvPr/>
        </p:nvSpPr>
        <p:spPr>
          <a:xfrm>
            <a:off x="6295649" y="142860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C0A0AE-D28B-4146-9820-E37D4D85E22C}"/>
              </a:ext>
            </a:extLst>
          </p:cNvPr>
          <p:cNvSpPr txBox="1"/>
          <p:nvPr/>
        </p:nvSpPr>
        <p:spPr>
          <a:xfrm>
            <a:off x="4683810" y="142860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CB98F28-9B20-4C5B-80A8-4C3FBBCCC1AC}"/>
              </a:ext>
            </a:extLst>
          </p:cNvPr>
          <p:cNvSpPr txBox="1"/>
          <p:nvPr/>
        </p:nvSpPr>
        <p:spPr>
          <a:xfrm>
            <a:off x="5788507" y="142860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0A7BAD-5DB6-41FF-9ACD-670842A3E885}"/>
              </a:ext>
            </a:extLst>
          </p:cNvPr>
          <p:cNvSpPr txBox="1"/>
          <p:nvPr/>
        </p:nvSpPr>
        <p:spPr>
          <a:xfrm>
            <a:off x="6880615" y="1428604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pic>
        <p:nvPicPr>
          <p:cNvPr id="11" name="Picture 10" descr="A picture containing photo, small, water, airplane&#10;&#10;Description automatically generated">
            <a:extLst>
              <a:ext uri="{FF2B5EF4-FFF2-40B4-BE49-F238E27FC236}">
                <a16:creationId xmlns:a16="http://schemas.microsoft.com/office/drawing/2014/main" id="{F4C80CF3-1DBE-4388-88C7-DBFCCBF6096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463" t="26316" r="40881" b="20395"/>
          <a:stretch/>
        </p:blipFill>
        <p:spPr>
          <a:xfrm>
            <a:off x="3449958" y="1928391"/>
            <a:ext cx="3923413" cy="328983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875B8D6-5B3B-4522-93F8-FF95CEA5833D}"/>
              </a:ext>
            </a:extLst>
          </p:cNvPr>
          <p:cNvSpPr txBox="1"/>
          <p:nvPr/>
        </p:nvSpPr>
        <p:spPr>
          <a:xfrm>
            <a:off x="2830429" y="5371207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1BEBCC-63AE-4641-879E-ABF48E277922}"/>
              </a:ext>
            </a:extLst>
          </p:cNvPr>
          <p:cNvSpPr txBox="1"/>
          <p:nvPr/>
        </p:nvSpPr>
        <p:spPr>
          <a:xfrm>
            <a:off x="2787849" y="5831961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468FC7B-2685-435B-A5D8-C5DFED5AF39D}"/>
              </a:ext>
            </a:extLst>
          </p:cNvPr>
          <p:cNvSpPr/>
          <p:nvPr/>
        </p:nvSpPr>
        <p:spPr>
          <a:xfrm>
            <a:off x="4491133" y="536604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83.9%</a:t>
            </a:r>
            <a:r>
              <a:rPr lang="en-GB" dirty="0"/>
              <a:t>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513D2AE-C632-46D8-BF5A-B95C5997D42D}"/>
              </a:ext>
            </a:extLst>
          </p:cNvPr>
          <p:cNvSpPr txBox="1"/>
          <p:nvPr/>
        </p:nvSpPr>
        <p:spPr>
          <a:xfrm>
            <a:off x="5319794" y="399506"/>
            <a:ext cx="11815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C49238C-1428-4FDC-AD8C-47337486881A}"/>
              </a:ext>
            </a:extLst>
          </p:cNvPr>
          <p:cNvCxnSpPr>
            <a:cxnSpLocks/>
          </p:cNvCxnSpPr>
          <p:nvPr/>
        </p:nvCxnSpPr>
        <p:spPr>
          <a:xfrm>
            <a:off x="5290562" y="1356019"/>
            <a:ext cx="94672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56807A1-9379-4FDB-8299-D3640CF1B540}"/>
              </a:ext>
            </a:extLst>
          </p:cNvPr>
          <p:cNvCxnSpPr>
            <a:cxnSpLocks/>
          </p:cNvCxnSpPr>
          <p:nvPr/>
        </p:nvCxnSpPr>
        <p:spPr>
          <a:xfrm>
            <a:off x="6401152" y="1362458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633A6AA-F7B1-4A9C-827F-E10EDEA6D845}"/>
              </a:ext>
            </a:extLst>
          </p:cNvPr>
          <p:cNvSpPr txBox="1"/>
          <p:nvPr/>
        </p:nvSpPr>
        <p:spPr>
          <a:xfrm>
            <a:off x="5173139" y="1001834"/>
            <a:ext cx="1181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MPCC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29E5B76-0123-477B-937F-464416D2BC98}"/>
              </a:ext>
            </a:extLst>
          </p:cNvPr>
          <p:cNvSpPr txBox="1"/>
          <p:nvPr/>
        </p:nvSpPr>
        <p:spPr>
          <a:xfrm>
            <a:off x="6321085" y="983678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MPCCP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3204E34B-2E7B-4A4A-8C48-DA310560B7DF}"/>
              </a:ext>
            </a:extLst>
          </p:cNvPr>
          <p:cNvCxnSpPr>
            <a:cxnSpLocks/>
          </p:cNvCxnSpPr>
          <p:nvPr/>
        </p:nvCxnSpPr>
        <p:spPr>
          <a:xfrm>
            <a:off x="4221638" y="1333159"/>
            <a:ext cx="84159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C7FCDF66-ADD3-4F5E-B956-42ACBCCC21D8}"/>
              </a:ext>
            </a:extLst>
          </p:cNvPr>
          <p:cNvSpPr txBox="1"/>
          <p:nvPr/>
        </p:nvSpPr>
        <p:spPr>
          <a:xfrm>
            <a:off x="4021621" y="1008784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MPCC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808977D-D007-4C8C-8B45-A6F753D3FEF0}"/>
              </a:ext>
            </a:extLst>
          </p:cNvPr>
          <p:cNvSpPr txBox="1"/>
          <p:nvPr/>
        </p:nvSpPr>
        <p:spPr>
          <a:xfrm>
            <a:off x="4181427" y="599352"/>
            <a:ext cx="1181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BE38C9B-6E42-4860-AB6C-9E41F9E8718F}"/>
              </a:ext>
            </a:extLst>
          </p:cNvPr>
          <p:cNvSpPr txBox="1"/>
          <p:nvPr/>
        </p:nvSpPr>
        <p:spPr>
          <a:xfrm>
            <a:off x="6499431" y="647548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348875E7-34AD-4C1D-8906-DB81CDADF96D}"/>
              </a:ext>
            </a:extLst>
          </p:cNvPr>
          <p:cNvSpPr/>
          <p:nvPr/>
        </p:nvSpPr>
        <p:spPr>
          <a:xfrm>
            <a:off x="5638297" y="536604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87.6%</a:t>
            </a:r>
            <a:r>
              <a:rPr lang="en-GB" dirty="0"/>
              <a:t> 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EB974C8-B937-4733-8F9F-2AC90078C11D}"/>
              </a:ext>
            </a:extLst>
          </p:cNvPr>
          <p:cNvSpPr/>
          <p:nvPr/>
        </p:nvSpPr>
        <p:spPr>
          <a:xfrm>
            <a:off x="5638297" y="5810608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98.3%</a:t>
            </a:r>
            <a:r>
              <a:rPr lang="en-GB" dirty="0"/>
              <a:t>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31F0FE6F-18C7-4869-B3A9-F33244BF650F}"/>
              </a:ext>
            </a:extLst>
          </p:cNvPr>
          <p:cNvSpPr/>
          <p:nvPr/>
        </p:nvSpPr>
        <p:spPr>
          <a:xfrm>
            <a:off x="6710336" y="5832477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0.6%</a:t>
            </a:r>
            <a:r>
              <a:rPr lang="en-GB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6AC41A1-7724-427A-85ED-755E4A79939A}"/>
              </a:ext>
            </a:extLst>
          </p:cNvPr>
          <p:cNvSpPr/>
          <p:nvPr/>
        </p:nvSpPr>
        <p:spPr>
          <a:xfrm>
            <a:off x="4753840" y="5801183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0488060-F5E7-4E6C-8853-5CACC49C6DAE}"/>
              </a:ext>
            </a:extLst>
          </p:cNvPr>
          <p:cNvSpPr/>
          <p:nvPr/>
        </p:nvSpPr>
        <p:spPr>
          <a:xfrm>
            <a:off x="6964637" y="5348685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728F40E-A501-4F6E-845B-11123414E9B1}"/>
              </a:ext>
            </a:extLst>
          </p:cNvPr>
          <p:cNvSpPr txBox="1"/>
          <p:nvPr/>
        </p:nvSpPr>
        <p:spPr>
          <a:xfrm>
            <a:off x="486478" y="817168"/>
            <a:ext cx="1317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0,000 RPM</a:t>
            </a:r>
          </a:p>
        </p:txBody>
      </p:sp>
    </p:spTree>
    <p:extLst>
      <p:ext uri="{BB962C8B-B14F-4D97-AF65-F5344CB8AC3E}">
        <p14:creationId xmlns:p14="http://schemas.microsoft.com/office/powerpoint/2010/main" val="817286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water, photo, small, sitting&#10;&#10;Description automatically generated">
            <a:extLst>
              <a:ext uri="{FF2B5EF4-FFF2-40B4-BE49-F238E27FC236}">
                <a16:creationId xmlns:a16="http://schemas.microsoft.com/office/drawing/2014/main" id="{0FE20DFB-88BB-43EE-8542-8A969129E6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222" t="18214" r="43415" b="25778"/>
          <a:stretch/>
        </p:blipFill>
        <p:spPr>
          <a:xfrm>
            <a:off x="2438399" y="1683000"/>
            <a:ext cx="3854807" cy="349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7ECF856-A925-48E2-BB0E-B5BBDDC6895C}"/>
              </a:ext>
            </a:extLst>
          </p:cNvPr>
          <p:cNvSpPr txBox="1"/>
          <p:nvPr/>
        </p:nvSpPr>
        <p:spPr>
          <a:xfrm>
            <a:off x="2845050" y="131366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76A31C-A28B-4EE1-B7B1-BFC40DCFC5D8}"/>
              </a:ext>
            </a:extLst>
          </p:cNvPr>
          <p:cNvSpPr txBox="1"/>
          <p:nvPr/>
        </p:nvSpPr>
        <p:spPr>
          <a:xfrm>
            <a:off x="4038342" y="131366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A61310E-3471-4580-9E10-DBBB24A9CBE1}"/>
              </a:ext>
            </a:extLst>
          </p:cNvPr>
          <p:cNvSpPr txBox="1"/>
          <p:nvPr/>
        </p:nvSpPr>
        <p:spPr>
          <a:xfrm>
            <a:off x="5076186" y="131366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595C7CD-D500-44DC-A5C5-9C5ACF48FF25}"/>
              </a:ext>
            </a:extLst>
          </p:cNvPr>
          <p:cNvSpPr txBox="1"/>
          <p:nvPr/>
        </p:nvSpPr>
        <p:spPr>
          <a:xfrm>
            <a:off x="3464347" y="131366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F3C0DD-67C4-4E0C-9141-5A4BCAC752BE}"/>
              </a:ext>
            </a:extLst>
          </p:cNvPr>
          <p:cNvSpPr txBox="1"/>
          <p:nvPr/>
        </p:nvSpPr>
        <p:spPr>
          <a:xfrm>
            <a:off x="4569044" y="131366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1D69B6-E506-43EB-A583-4166F9A36B13}"/>
              </a:ext>
            </a:extLst>
          </p:cNvPr>
          <p:cNvSpPr txBox="1"/>
          <p:nvPr/>
        </p:nvSpPr>
        <p:spPr>
          <a:xfrm>
            <a:off x="5661152" y="1313668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94AF23A-C21E-4055-979F-F5572D2D404E}"/>
              </a:ext>
            </a:extLst>
          </p:cNvPr>
          <p:cNvSpPr txBox="1"/>
          <p:nvPr/>
        </p:nvSpPr>
        <p:spPr>
          <a:xfrm>
            <a:off x="2926653" y="360975"/>
            <a:ext cx="11815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725B54E-CCEB-4BEA-A390-529AE82C23B2}"/>
              </a:ext>
            </a:extLst>
          </p:cNvPr>
          <p:cNvCxnSpPr>
            <a:cxnSpLocks/>
          </p:cNvCxnSpPr>
          <p:nvPr/>
        </p:nvCxnSpPr>
        <p:spPr>
          <a:xfrm>
            <a:off x="4071099" y="1241083"/>
            <a:ext cx="94672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60C11706-F7AB-4CB9-9A59-CB9A6B8BE0DA}"/>
              </a:ext>
            </a:extLst>
          </p:cNvPr>
          <p:cNvCxnSpPr>
            <a:cxnSpLocks/>
          </p:cNvCxnSpPr>
          <p:nvPr/>
        </p:nvCxnSpPr>
        <p:spPr>
          <a:xfrm>
            <a:off x="5181689" y="1247522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6413099-0474-4A3A-89BE-FF415C02550B}"/>
              </a:ext>
            </a:extLst>
          </p:cNvPr>
          <p:cNvSpPr txBox="1"/>
          <p:nvPr/>
        </p:nvSpPr>
        <p:spPr>
          <a:xfrm>
            <a:off x="3953676" y="886898"/>
            <a:ext cx="1181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MPCC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705A095-EE2B-4A5C-9920-E84DCB19757F}"/>
              </a:ext>
            </a:extLst>
          </p:cNvPr>
          <p:cNvSpPr txBox="1"/>
          <p:nvPr/>
        </p:nvSpPr>
        <p:spPr>
          <a:xfrm>
            <a:off x="5101622" y="868742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MPCCP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04A53EA-F497-4CF4-AD7F-8778B51E948D}"/>
              </a:ext>
            </a:extLst>
          </p:cNvPr>
          <p:cNvCxnSpPr>
            <a:cxnSpLocks/>
          </p:cNvCxnSpPr>
          <p:nvPr/>
        </p:nvCxnSpPr>
        <p:spPr>
          <a:xfrm>
            <a:off x="3002175" y="1218223"/>
            <a:ext cx="84159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1D45C2C-1C8A-442C-949A-7CF197FCCF81}"/>
              </a:ext>
            </a:extLst>
          </p:cNvPr>
          <p:cNvSpPr txBox="1"/>
          <p:nvPr/>
        </p:nvSpPr>
        <p:spPr>
          <a:xfrm>
            <a:off x="2802158" y="893848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MPCC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BFB238C-5E26-4728-9D41-2B503E28A4D0}"/>
              </a:ext>
            </a:extLst>
          </p:cNvPr>
          <p:cNvSpPr txBox="1"/>
          <p:nvPr/>
        </p:nvSpPr>
        <p:spPr>
          <a:xfrm>
            <a:off x="4116089" y="575004"/>
            <a:ext cx="1181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FB9BCF1-74B1-4BDD-BE06-EC69E02A94F7}"/>
              </a:ext>
            </a:extLst>
          </p:cNvPr>
          <p:cNvSpPr txBox="1"/>
          <p:nvPr/>
        </p:nvSpPr>
        <p:spPr>
          <a:xfrm>
            <a:off x="5279968" y="532612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4414A24-F9B0-4F96-8C4C-25AE6BA5FDCD}"/>
              </a:ext>
            </a:extLst>
          </p:cNvPr>
          <p:cNvSpPr txBox="1"/>
          <p:nvPr/>
        </p:nvSpPr>
        <p:spPr>
          <a:xfrm>
            <a:off x="1354663" y="5179023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54BBF86-6F77-4921-9C94-BBC0DE1A526B}"/>
              </a:ext>
            </a:extLst>
          </p:cNvPr>
          <p:cNvSpPr txBox="1"/>
          <p:nvPr/>
        </p:nvSpPr>
        <p:spPr>
          <a:xfrm>
            <a:off x="1312083" y="5639777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E6C22B1-10AD-4419-89D2-222077EE3658}"/>
              </a:ext>
            </a:extLst>
          </p:cNvPr>
          <p:cNvSpPr/>
          <p:nvPr/>
        </p:nvSpPr>
        <p:spPr>
          <a:xfrm>
            <a:off x="3362296" y="511850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87.4%</a:t>
            </a:r>
            <a:r>
              <a:rPr lang="en-GB" dirty="0"/>
              <a:t> 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3714D73-E5FA-4C70-BC17-B2D46A282A06}"/>
              </a:ext>
            </a:extLst>
          </p:cNvPr>
          <p:cNvSpPr/>
          <p:nvPr/>
        </p:nvSpPr>
        <p:spPr>
          <a:xfrm>
            <a:off x="4574282" y="5146750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81.9%</a:t>
            </a:r>
            <a:r>
              <a:rPr lang="en-GB" dirty="0"/>
              <a:t>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33D0E886-E110-4769-9955-25C462C3FF89}"/>
              </a:ext>
            </a:extLst>
          </p:cNvPr>
          <p:cNvSpPr/>
          <p:nvPr/>
        </p:nvSpPr>
        <p:spPr>
          <a:xfrm>
            <a:off x="3303289" y="5544332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96.9%</a:t>
            </a:r>
            <a:r>
              <a:rPr lang="en-GB" dirty="0"/>
              <a:t> 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7F4D27B4-2F6E-4792-9483-CCD9F7961372}"/>
              </a:ext>
            </a:extLst>
          </p:cNvPr>
          <p:cNvSpPr/>
          <p:nvPr/>
        </p:nvSpPr>
        <p:spPr>
          <a:xfrm>
            <a:off x="5627180" y="5544332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6.8%</a:t>
            </a:r>
            <a:r>
              <a:rPr lang="en-GB" dirty="0"/>
              <a:t>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A175DBD-047E-4072-B039-1BCEAD887B19}"/>
              </a:ext>
            </a:extLst>
          </p:cNvPr>
          <p:cNvSpPr/>
          <p:nvPr/>
        </p:nvSpPr>
        <p:spPr>
          <a:xfrm>
            <a:off x="4767232" y="5515050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EA39379-8AB7-4E44-A6FC-14EAB804AC9F}"/>
              </a:ext>
            </a:extLst>
          </p:cNvPr>
          <p:cNvSpPr/>
          <p:nvPr/>
        </p:nvSpPr>
        <p:spPr>
          <a:xfrm>
            <a:off x="5816600" y="5118500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1A67A87-D033-41E6-BD04-A787906F59FE}"/>
              </a:ext>
            </a:extLst>
          </p:cNvPr>
          <p:cNvSpPr txBox="1"/>
          <p:nvPr/>
        </p:nvSpPr>
        <p:spPr>
          <a:xfrm>
            <a:off x="518362" y="1492963"/>
            <a:ext cx="1661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EL 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49CD413-39BF-461D-AC22-31329C6731FA}"/>
              </a:ext>
            </a:extLst>
          </p:cNvPr>
          <p:cNvSpPr txBox="1"/>
          <p:nvPr/>
        </p:nvSpPr>
        <p:spPr>
          <a:xfrm>
            <a:off x="332173" y="529401"/>
            <a:ext cx="1317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0,000 RP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7673EF7-32E3-4827-B7FA-5F3A65840749}"/>
              </a:ext>
            </a:extLst>
          </p:cNvPr>
          <p:cNvSpPr txBox="1"/>
          <p:nvPr/>
        </p:nvSpPr>
        <p:spPr>
          <a:xfrm>
            <a:off x="10759107" y="30174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2</a:t>
            </a:r>
          </a:p>
        </p:txBody>
      </p:sp>
    </p:spTree>
    <p:extLst>
      <p:ext uri="{BB962C8B-B14F-4D97-AF65-F5344CB8AC3E}">
        <p14:creationId xmlns:p14="http://schemas.microsoft.com/office/powerpoint/2010/main" val="2075694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Widescreen</PresentationFormat>
  <Paragraphs>4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Schlimpert (JIC)</dc:creator>
  <cp:lastModifiedBy>Susan Schlimpert (JIC)</cp:lastModifiedBy>
  <cp:revision>1</cp:revision>
  <dcterms:created xsi:type="dcterms:W3CDTF">2021-01-12T19:30:15Z</dcterms:created>
  <dcterms:modified xsi:type="dcterms:W3CDTF">2021-01-12T19:30:55Z</dcterms:modified>
</cp:coreProperties>
</file>